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png" ContentType="image/png"/>
  <Override PartName="/ppt/media/image6.wmf" ContentType="image/x-wmf"/>
  <Override PartName="/ppt/media/image7.wmf" ContentType="image/x-wmf"/>
  <Override PartName="/ppt/media/image8.wmf" ContentType="image/x-wmf"/>
  <Override PartName="/ppt/media/image9.png" ContentType="image/png"/>
  <Override PartName="/ppt/media/image10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6858000" cy="9907588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98240" y="696960"/>
            <a:ext cx="241308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2D344E-A28A-4CE5-8D41-F3CEC73CD962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ldImg"/>
          </p:nvPr>
        </p:nvSpPr>
        <p:spPr>
          <a:xfrm>
            <a:off x="2298600" y="696960"/>
            <a:ext cx="2413080" cy="3486240"/>
          </a:xfrm>
          <a:prstGeom prst="rect">
            <a:avLst/>
          </a:prstGeom>
          <a:ln w="0">
            <a:noFill/>
          </a:ln>
        </p:spPr>
      </p:sp>
      <p:sp>
        <p:nvSpPr>
          <p:cNvPr id="12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628FBE-02EB-495B-BEF6-667C725EBC70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sldImg"/>
          </p:nvPr>
        </p:nvSpPr>
        <p:spPr>
          <a:xfrm>
            <a:off x="2298600" y="696960"/>
            <a:ext cx="2413080" cy="3486240"/>
          </a:xfrm>
          <a:prstGeom prst="rect">
            <a:avLst/>
          </a:prstGeom>
          <a:ln w="0">
            <a:noFill/>
          </a:ln>
        </p:spPr>
      </p:sp>
      <p:sp>
        <p:nvSpPr>
          <p:cNvPr id="12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CDB17A-5FBB-48D8-AC08-1AC76D7B8DA3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sldImg"/>
          </p:nvPr>
        </p:nvSpPr>
        <p:spPr>
          <a:xfrm>
            <a:off x="2298600" y="696960"/>
            <a:ext cx="2413080" cy="3486240"/>
          </a:xfrm>
          <a:prstGeom prst="rect">
            <a:avLst/>
          </a:prstGeom>
          <a:ln w="0">
            <a:noFill/>
          </a:ln>
        </p:spPr>
      </p:sp>
      <p:sp>
        <p:nvSpPr>
          <p:cNvPr id="12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91E953-636E-46B6-AEC0-936FA56FECD2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sldImg"/>
          </p:nvPr>
        </p:nvSpPr>
        <p:spPr>
          <a:xfrm>
            <a:off x="2298600" y="696960"/>
            <a:ext cx="2413080" cy="3486240"/>
          </a:xfrm>
          <a:prstGeom prst="rect">
            <a:avLst/>
          </a:prstGeom>
          <a:ln w="0">
            <a:noFill/>
          </a:ln>
        </p:spPr>
      </p:sp>
      <p:sp>
        <p:nvSpPr>
          <p:cNvPr id="131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39050C6-BB37-4DB8-8A76-643EE3828D4C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sldImg"/>
          </p:nvPr>
        </p:nvSpPr>
        <p:spPr>
          <a:xfrm>
            <a:off x="2298600" y="696960"/>
            <a:ext cx="2413080" cy="3486240"/>
          </a:xfrm>
          <a:prstGeom prst="rect">
            <a:avLst/>
          </a:prstGeom>
          <a:ln w="0">
            <a:noFill/>
          </a:ln>
        </p:spPr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8173B8-7697-428D-B3B3-226A0B2579E5}" type="slidenum">
              <a:rPr b="0" lang="en-CA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6B5E7-76EC-4ACF-93A3-6858E88BDF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68DDD1-691B-467E-B440-3CDD969A92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215FD-52EA-49E3-9AD0-F9A6E0A0C2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6B4AF-DC6D-43E1-AEC7-E439D7B77A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92588-24C8-491A-8443-C3B2A991B3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CD8B0-BA5B-4986-8A85-217F30D2C7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159485-66BF-4FFA-B9F5-72BD8C482F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87F54-5D8D-4DA8-A5F1-9D0E612FF8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DDD95-7904-488A-BF01-7B2147B70C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42485-11B1-4CC8-91F9-A7B93A295F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A63E0-1E8C-4621-977C-BF02E9E659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B8384-1FEC-44C6-A1E3-93B2EBF6AF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D759A9-9542-4BC2-B0B3-02731EAAF7A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5"/>
          <p:cNvGrpSpPr/>
          <p:nvPr/>
        </p:nvGrpSpPr>
        <p:grpSpPr>
          <a:xfrm>
            <a:off x="1096920" y="1281240"/>
            <a:ext cx="4392720" cy="3671280"/>
            <a:chOff x="1096920" y="1281240"/>
            <a:chExt cx="4392720" cy="3671280"/>
          </a:xfrm>
        </p:grpSpPr>
        <p:sp>
          <p:nvSpPr>
            <p:cNvPr id="49" name="TextBox 9"/>
            <p:cNvSpPr/>
            <p:nvPr/>
          </p:nvSpPr>
          <p:spPr>
            <a:xfrm>
              <a:off x="2642400" y="4676040"/>
              <a:ext cx="199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op X interactions of P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9"/>
            <p:cNvSpPr/>
            <p:nvPr/>
          </p:nvSpPr>
          <p:spPr>
            <a:xfrm rot="16200000">
              <a:off x="803160" y="2683440"/>
              <a:ext cx="10465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etwork 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teractio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9"/>
            <p:cNvSpPr/>
            <p:nvPr/>
          </p:nvSpPr>
          <p:spPr>
            <a:xfrm>
              <a:off x="2857680" y="1281240"/>
              <a:ext cx="186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verage of Network 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6" descr=""/>
            <p:cNvPicPr/>
            <p:nvPr/>
          </p:nvPicPr>
          <p:blipFill>
            <a:blip r:embed="rId1"/>
            <a:stretch/>
          </p:blipFill>
          <p:spPr>
            <a:xfrm>
              <a:off x="1557000" y="1712880"/>
              <a:ext cx="3932640" cy="2983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3" name="TextBox 6"/>
          <p:cNvSpPr/>
          <p:nvPr/>
        </p:nvSpPr>
        <p:spPr>
          <a:xfrm>
            <a:off x="500400" y="344520"/>
            <a:ext cx="615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1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-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etwork A interactions are distributed evenly across the top 60,000 of the 94,879 interactions 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IN. Coverage of Network A (rich in membrane interactions) is shown for interactions with differ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toffs of PI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13"/>
          <p:cNvGrpSpPr/>
          <p:nvPr/>
        </p:nvGrpSpPr>
        <p:grpSpPr>
          <a:xfrm>
            <a:off x="777960" y="2432160"/>
            <a:ext cx="5385600" cy="5461200"/>
            <a:chOff x="777960" y="2432160"/>
            <a:chExt cx="5385600" cy="5461200"/>
          </a:xfrm>
        </p:grpSpPr>
        <p:pic>
          <p:nvPicPr>
            <p:cNvPr id="55" name="Picture 3" descr=""/>
            <p:cNvPicPr/>
            <p:nvPr/>
          </p:nvPicPr>
          <p:blipFill>
            <a:blip r:embed="rId1"/>
            <a:stretch/>
          </p:blipFill>
          <p:spPr>
            <a:xfrm>
              <a:off x="1290600" y="3008160"/>
              <a:ext cx="4608360" cy="342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6" name="TextBox 5"/>
            <p:cNvSpPr/>
            <p:nvPr/>
          </p:nvSpPr>
          <p:spPr>
            <a:xfrm rot="16200000">
              <a:off x="5722920" y="4723560"/>
              <a:ext cx="543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AU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8"/>
            <p:cNvSpPr/>
            <p:nvPr/>
          </p:nvSpPr>
          <p:spPr>
            <a:xfrm>
              <a:off x="2949120" y="7616880"/>
              <a:ext cx="1499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Calibri"/>
                </a:rPr>
                <a:t>Weight of network 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ight Triangle 4"/>
            <p:cNvSpPr/>
            <p:nvPr/>
          </p:nvSpPr>
          <p:spPr>
            <a:xfrm rot="16200000">
              <a:off x="3511440" y="5611680"/>
              <a:ext cx="311040" cy="3600360"/>
            </a:xfrm>
            <a:prstGeom prst="rtTriangle">
              <a:avLst/>
            </a:prstGeom>
            <a:solidFill>
              <a:srgbClr val="000000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ight Triangle 5"/>
            <p:cNvSpPr/>
            <p:nvPr/>
          </p:nvSpPr>
          <p:spPr>
            <a:xfrm rot="5400000">
              <a:off x="3522240" y="5456160"/>
              <a:ext cx="288720" cy="3600360"/>
            </a:xfrm>
            <a:prstGeom prst="rtTriangle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6"/>
            <p:cNvSpPr/>
            <p:nvPr/>
          </p:nvSpPr>
          <p:spPr>
            <a:xfrm>
              <a:off x="2989080" y="6836040"/>
              <a:ext cx="1546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ff"/>
                  </a:solidFill>
                  <a:latin typeface="Calibri"/>
                </a:rPr>
                <a:t>Weight of network A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3"/>
            <p:cNvSpPr/>
            <p:nvPr/>
          </p:nvSpPr>
          <p:spPr>
            <a:xfrm>
              <a:off x="2918160" y="6319800"/>
              <a:ext cx="1716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Calibri"/>
                </a:rPr>
                <a:t>Weight of network 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8"/>
            <p:cNvSpPr/>
            <p:nvPr/>
          </p:nvSpPr>
          <p:spPr>
            <a:xfrm rot="16200000">
              <a:off x="5958720" y="4140720"/>
              <a:ext cx="88560" cy="10944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10"/>
            <p:cNvSpPr/>
            <p:nvPr/>
          </p:nvSpPr>
          <p:spPr>
            <a:xfrm flipV="1">
              <a:off x="6004080" y="3930480"/>
              <a:ext cx="0" cy="5745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5"/>
            <p:cNvSpPr/>
            <p:nvPr/>
          </p:nvSpPr>
          <p:spPr>
            <a:xfrm rot="16200000">
              <a:off x="2880" y="4460760"/>
              <a:ext cx="2130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Interactions betwee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embrane protein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16"/>
            <p:cNvSpPr/>
            <p:nvPr/>
          </p:nvSpPr>
          <p:spPr>
            <a:xfrm>
              <a:off x="993600" y="3440160"/>
              <a:ext cx="144360" cy="142560"/>
            </a:xfrm>
            <a:prstGeom prst="rect">
              <a:avLst/>
            </a:prstGeom>
            <a:solidFill>
              <a:srgbClr val="0066ff"/>
            </a:solidFill>
            <a:ln w="25560">
              <a:solidFill>
                <a:srgbClr val="0066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12"/>
            <p:cNvSpPr/>
            <p:nvPr/>
          </p:nvSpPr>
          <p:spPr>
            <a:xfrm>
              <a:off x="3166560" y="2432160"/>
              <a:ext cx="702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iREF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TextBox 14"/>
          <p:cNvSpPr/>
          <p:nvPr/>
        </p:nvSpPr>
        <p:spPr>
          <a:xfrm>
            <a:off x="220680" y="128520"/>
            <a:ext cx="660564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Figure S2 – Construction of iREF network as a control weighted network. 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The</a:t>
            </a: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iREF network was construct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by the optimized  combination of two networks: A’ comprised of interactions not previously used from the iRE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database and B, the same network  B used to construct PIN. The Area Under Curve (AUC) of  Precision-Recall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plots for the top 5,000 interactions was used  for selecting the optimum weight for network B using membran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proteins from GO Slim as an established benchmark dataset. The AUC was calculated for different weights fo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network B, and the weight corresponding to accuracy in the plateau with higher number of membrane interac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(AUC = 0.38) was chosen the optimal weight of network B was0.8.  Like PIN the performance of this network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increased with increasing membrane interaction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Box 13"/>
          <p:cNvSpPr/>
          <p:nvPr/>
        </p:nvSpPr>
        <p:spPr>
          <a:xfrm>
            <a:off x="-6480" y="1300320"/>
            <a:ext cx="39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"/>
          <p:cNvSpPr/>
          <p:nvPr/>
        </p:nvSpPr>
        <p:spPr>
          <a:xfrm>
            <a:off x="3179160" y="1332000"/>
            <a:ext cx="38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"/>
          <p:cNvSpPr/>
          <p:nvPr/>
        </p:nvSpPr>
        <p:spPr>
          <a:xfrm>
            <a:off x="29520" y="5600880"/>
            <a:ext cx="372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0"/>
          <p:cNvSpPr/>
          <p:nvPr/>
        </p:nvSpPr>
        <p:spPr>
          <a:xfrm>
            <a:off x="0" y="57240"/>
            <a:ext cx="66960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3 –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enrichment analysis of PIN showing over-represented gene categories (red) occur in the lower significance quintiles. The analysis was repeated 10 times by randomly resampling 1000 interactions in each different quintile of the network (I-V). The median p-value of the 10 analysis is shown. A) Cell compartment. B) Biological process. C) Molecular function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4" descr=""/>
          <p:cNvPicPr/>
          <p:nvPr/>
        </p:nvPicPr>
        <p:blipFill>
          <a:blip r:embed="rId1"/>
          <a:stretch/>
        </p:blipFill>
        <p:spPr>
          <a:xfrm>
            <a:off x="3645000" y="1587600"/>
            <a:ext cx="2773440" cy="496728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5" descr=""/>
          <p:cNvPicPr/>
          <p:nvPr/>
        </p:nvPicPr>
        <p:blipFill>
          <a:blip r:embed="rId2"/>
          <a:stretch/>
        </p:blipFill>
        <p:spPr>
          <a:xfrm>
            <a:off x="519120" y="5754600"/>
            <a:ext cx="3054240" cy="3797280"/>
          </a:xfrm>
          <a:prstGeom prst="rect">
            <a:avLst/>
          </a:prstGeom>
          <a:ln w="0">
            <a:noFill/>
          </a:ln>
        </p:spPr>
      </p:pic>
      <p:grpSp>
        <p:nvGrpSpPr>
          <p:cNvPr id="74" name="Group 32"/>
          <p:cNvGrpSpPr/>
          <p:nvPr/>
        </p:nvGrpSpPr>
        <p:grpSpPr>
          <a:xfrm>
            <a:off x="333360" y="1660680"/>
            <a:ext cx="2519280" cy="3600360"/>
            <a:chOff x="333360" y="1660680"/>
            <a:chExt cx="2519280" cy="3600360"/>
          </a:xfrm>
        </p:grpSpPr>
        <p:grpSp>
          <p:nvGrpSpPr>
            <p:cNvPr id="75" name="Group 13"/>
            <p:cNvGrpSpPr/>
            <p:nvPr/>
          </p:nvGrpSpPr>
          <p:grpSpPr>
            <a:xfrm>
              <a:off x="333360" y="1943640"/>
              <a:ext cx="2519280" cy="3317400"/>
              <a:chOff x="333360" y="1943640"/>
              <a:chExt cx="2519280" cy="3317400"/>
            </a:xfrm>
          </p:grpSpPr>
          <p:pic>
            <p:nvPicPr>
              <p:cNvPr id="76" name="Picture 40" descr="CC_merged_heat_map_paper.png"/>
              <p:cNvPicPr/>
              <p:nvPr/>
            </p:nvPicPr>
            <p:blipFill>
              <a:blip r:embed="rId3"/>
              <a:stretch/>
            </p:blipFill>
            <p:spPr>
              <a:xfrm>
                <a:off x="333360" y="1944000"/>
                <a:ext cx="2519280" cy="331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Rectangle 41"/>
              <p:cNvSpPr/>
              <p:nvPr/>
            </p:nvSpPr>
            <p:spPr>
              <a:xfrm>
                <a:off x="574560" y="1943640"/>
                <a:ext cx="933480" cy="271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8" name="Group 11"/>
            <p:cNvGrpSpPr/>
            <p:nvPr/>
          </p:nvGrpSpPr>
          <p:grpSpPr>
            <a:xfrm>
              <a:off x="585720" y="1660680"/>
              <a:ext cx="824040" cy="498240"/>
              <a:chOff x="585720" y="1660680"/>
              <a:chExt cx="824040" cy="498240"/>
            </a:xfrm>
          </p:grpSpPr>
          <p:sp>
            <p:nvSpPr>
              <p:cNvPr id="79" name="TextBox 35"/>
              <p:cNvSpPr/>
              <p:nvPr/>
            </p:nvSpPr>
            <p:spPr>
              <a:xfrm>
                <a:off x="629640" y="1944000"/>
                <a:ext cx="769320" cy="21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700" spc="-1" strike="noStrike">
                    <a:solidFill>
                      <a:srgbClr val="000000"/>
                    </a:solidFill>
                    <a:latin typeface="Arial"/>
                  </a:rPr>
                  <a:t>-log</a:t>
                </a:r>
                <a:r>
                  <a:rPr b="1" lang="en-CA" sz="7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r>
                  <a:rPr b="1" lang="en-CA" sz="700" spc="-1" strike="noStrike">
                    <a:solidFill>
                      <a:srgbClr val="000000"/>
                    </a:solidFill>
                    <a:latin typeface="Arial"/>
                  </a:rPr>
                  <a:t>(P-value)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Box 36"/>
              <p:cNvSpPr/>
              <p:nvPr/>
            </p:nvSpPr>
            <p:spPr>
              <a:xfrm>
                <a:off x="843480" y="166068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7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Box 37"/>
              <p:cNvSpPr/>
              <p:nvPr/>
            </p:nvSpPr>
            <p:spPr>
              <a:xfrm>
                <a:off x="1131480" y="166068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7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Box 38"/>
              <p:cNvSpPr/>
              <p:nvPr/>
            </p:nvSpPr>
            <p:spPr>
              <a:xfrm>
                <a:off x="585720" y="16606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39"/>
              <p:cNvSpPr/>
              <p:nvPr/>
            </p:nvSpPr>
            <p:spPr>
              <a:xfrm>
                <a:off x="669600" y="1876680"/>
                <a:ext cx="596880" cy="73080"/>
              </a:xfrm>
              <a:prstGeom prst="rect">
                <a:avLst/>
              </a:prstGeom>
              <a:gradFill rotWithShape="0">
                <a:gsLst>
                  <a:gs pos="0">
                    <a:srgbClr val="0b0bb5"/>
                  </a:gs>
                  <a:gs pos="100000">
                    <a:srgbClr val="4d0808"/>
                  </a:gs>
                </a:gsLst>
                <a:lin ang="0"/>
              </a:gra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4" name="AutoShape 18"/>
          <p:cNvSpPr/>
          <p:nvPr/>
        </p:nvSpPr>
        <p:spPr>
          <a:xfrm>
            <a:off x="3645000" y="1587600"/>
            <a:ext cx="2773440" cy="496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2" descr=""/>
          <p:cNvPicPr/>
          <p:nvPr/>
        </p:nvPicPr>
        <p:blipFill>
          <a:blip r:embed="rId1"/>
          <a:stretch/>
        </p:blipFill>
        <p:spPr>
          <a:xfrm>
            <a:off x="333360" y="1568520"/>
            <a:ext cx="3154320" cy="2752560"/>
          </a:xfrm>
          <a:prstGeom prst="rect">
            <a:avLst/>
          </a:prstGeom>
          <a:ln w="0">
            <a:noFill/>
          </a:ln>
        </p:spPr>
      </p:pic>
      <p:sp>
        <p:nvSpPr>
          <p:cNvPr id="86" name="TextBox 18"/>
          <p:cNvSpPr/>
          <p:nvPr/>
        </p:nvSpPr>
        <p:spPr>
          <a:xfrm rot="16200000">
            <a:off x="-514440" y="2514600"/>
            <a:ext cx="136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Interac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3"/>
          <p:cNvSpPr/>
          <p:nvPr/>
        </p:nvSpPr>
        <p:spPr>
          <a:xfrm>
            <a:off x="1267200" y="4305240"/>
            <a:ext cx="1707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op X interac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22"/>
          <p:cNvSpPr/>
          <p:nvPr/>
        </p:nvSpPr>
        <p:spPr>
          <a:xfrm>
            <a:off x="1032120" y="1230480"/>
            <a:ext cx="205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Membrane complex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3" descr=""/>
          <p:cNvPicPr/>
          <p:nvPr/>
        </p:nvPicPr>
        <p:blipFill>
          <a:blip r:embed="rId2"/>
          <a:stretch/>
        </p:blipFill>
        <p:spPr>
          <a:xfrm>
            <a:off x="3716280" y="1541520"/>
            <a:ext cx="3168720" cy="2763720"/>
          </a:xfrm>
          <a:prstGeom prst="rect">
            <a:avLst/>
          </a:prstGeom>
          <a:ln w="0">
            <a:noFill/>
          </a:ln>
        </p:spPr>
      </p:pic>
      <p:sp>
        <p:nvSpPr>
          <p:cNvPr id="90" name="TextBox 18"/>
          <p:cNvSpPr/>
          <p:nvPr/>
        </p:nvSpPr>
        <p:spPr>
          <a:xfrm rot="16200000">
            <a:off x="2914200" y="2667240"/>
            <a:ext cx="1366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Interac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2"/>
          <p:cNvSpPr/>
          <p:nvPr/>
        </p:nvSpPr>
        <p:spPr>
          <a:xfrm>
            <a:off x="4748760" y="1208160"/>
            <a:ext cx="1537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ransport gen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9"/>
          <p:cNvSpPr/>
          <p:nvPr/>
        </p:nvSpPr>
        <p:spPr>
          <a:xfrm>
            <a:off x="4629240" y="4305240"/>
            <a:ext cx="1707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Top X interac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12"/>
          <p:cNvSpPr/>
          <p:nvPr/>
        </p:nvSpPr>
        <p:spPr>
          <a:xfrm>
            <a:off x="476280" y="415800"/>
            <a:ext cx="61927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Calibri"/>
              </a:rPr>
              <a:t>Figure S4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Calibri"/>
              </a:rPr>
              <a:t> - PIN increases the proportion of membrane associated interactions in the network compared to a hypergeometric model or random scoring.  Coverage of interactions by PIN of genes with related GO terms. A) membrane complexes or B) Transport gen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0"/>
          <p:cNvSpPr/>
          <p:nvPr/>
        </p:nvSpPr>
        <p:spPr>
          <a:xfrm>
            <a:off x="430200" y="4808520"/>
            <a:ext cx="543384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mbrane complexes-associated GO terms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30119 : AP-type membrane coat adaptor complex [17 proteins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72546 : ER membrane protein complex [6 proteins]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05744 : mitochondrial inner membrane presequence translocase complex [11 proteins]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05742 : mitochondrial outer membrane translocase complex [8 proteins]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30119 : AP-type membrane coat adaptor complex [17 proteins]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72379 : ER membrane insertion complex [7 proteins]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O:0005744 : mitochondrial inner membrane presequence translocase complex [11 proteins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5" name="Group 13"/>
          <p:cNvGrpSpPr/>
          <p:nvPr/>
        </p:nvGrpSpPr>
        <p:grpSpPr>
          <a:xfrm>
            <a:off x="836640" y="849240"/>
            <a:ext cx="4809960" cy="2963880"/>
            <a:chOff x="836640" y="849240"/>
            <a:chExt cx="4809960" cy="2963880"/>
          </a:xfrm>
        </p:grpSpPr>
        <p:sp>
          <p:nvSpPr>
            <p:cNvPr id="96" name="TextBox 7"/>
            <p:cNvSpPr/>
            <p:nvPr/>
          </p:nvSpPr>
          <p:spPr>
            <a:xfrm rot="16200000">
              <a:off x="209880" y="2189880"/>
              <a:ext cx="1773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orrelation with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embrane cont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10"/>
            <p:cNvSpPr/>
            <p:nvPr/>
          </p:nvSpPr>
          <p:spPr>
            <a:xfrm>
              <a:off x="3214800" y="849240"/>
              <a:ext cx="1078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Cutoff (k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8" name="Picture 13" descr=""/>
            <p:cNvPicPr/>
            <p:nvPr/>
          </p:nvPicPr>
          <p:blipFill>
            <a:blip r:embed="rId1"/>
            <a:stretch/>
          </p:blipFill>
          <p:spPr>
            <a:xfrm>
              <a:off x="1350360" y="1115640"/>
              <a:ext cx="4296240" cy="26974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9" name="TextBox 12"/>
          <p:cNvSpPr/>
          <p:nvPr/>
        </p:nvSpPr>
        <p:spPr>
          <a:xfrm>
            <a:off x="252360" y="272880"/>
            <a:ext cx="596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5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- Correlation between Indess(k) and membrane content varies with k, but is always negativ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extBox 2"/>
          <p:cNvSpPr/>
          <p:nvPr/>
        </p:nvSpPr>
        <p:spPr>
          <a:xfrm>
            <a:off x="208800" y="200160"/>
            <a:ext cx="655272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 S6 – Hierarchical clustering using PIN separates starvation induced genes from other autophag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rocess genes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similarity between interactions was used to build a dendrogram where each leaf is a link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interaction) from the original network and branches represent link (interaction) communities. Each row or colum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esents an interaction in the autophagy network and the values in the matrix are Z-scored similarity distance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etween interactions. The red squares in the matrix represent modules as sets of closely interrelated interaction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ach square in the matrix was examined for overlap with each ATG process and annotated manually (bars to th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ight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23"/>
          <p:cNvGrpSpPr/>
          <p:nvPr/>
        </p:nvGrpSpPr>
        <p:grpSpPr>
          <a:xfrm>
            <a:off x="404640" y="1424160"/>
            <a:ext cx="6399720" cy="5400360"/>
            <a:chOff x="404640" y="1424160"/>
            <a:chExt cx="6399720" cy="5400360"/>
          </a:xfrm>
        </p:grpSpPr>
        <p:grpSp>
          <p:nvGrpSpPr>
            <p:cNvPr id="102" name="Group 16"/>
            <p:cNvGrpSpPr/>
            <p:nvPr/>
          </p:nvGrpSpPr>
          <p:grpSpPr>
            <a:xfrm>
              <a:off x="404640" y="1695240"/>
              <a:ext cx="6399720" cy="5129280"/>
              <a:chOff x="404640" y="1695240"/>
              <a:chExt cx="6399720" cy="5129280"/>
            </a:xfrm>
          </p:grpSpPr>
          <p:pic>
            <p:nvPicPr>
              <p:cNvPr id="103" name="Picture 1" descr="temp.png"/>
              <p:cNvPicPr/>
              <p:nvPr/>
            </p:nvPicPr>
            <p:blipFill>
              <a:blip r:embed="rId1"/>
              <a:stretch/>
            </p:blipFill>
            <p:spPr>
              <a:xfrm>
                <a:off x="404640" y="1695240"/>
                <a:ext cx="5075280" cy="51292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04" name="Group 15"/>
              <p:cNvGrpSpPr/>
              <p:nvPr/>
            </p:nvGrpSpPr>
            <p:grpSpPr>
              <a:xfrm>
                <a:off x="5451120" y="2344320"/>
                <a:ext cx="1353240" cy="4464000"/>
                <a:chOff x="5451120" y="2344320"/>
                <a:chExt cx="1353240" cy="4464000"/>
              </a:xfrm>
            </p:grpSpPr>
            <p:sp>
              <p:nvSpPr>
                <p:cNvPr id="105" name="TextBox 16"/>
                <p:cNvSpPr/>
                <p:nvPr/>
              </p:nvSpPr>
              <p:spPr>
                <a:xfrm>
                  <a:off x="5642280" y="4431600"/>
                  <a:ext cx="855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Pexophagy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Straight Connector 17"/>
                <p:cNvSpPr/>
                <p:nvPr/>
              </p:nvSpPr>
              <p:spPr>
                <a:xfrm>
                  <a:off x="5517720" y="6305400"/>
                  <a:ext cx="0" cy="502920"/>
                </a:xfrm>
                <a:prstGeom prst="line">
                  <a:avLst/>
                </a:prstGeom>
                <a:ln w="76320">
                  <a:solidFill>
                    <a:srgbClr val="00b0f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TextBox 18"/>
                <p:cNvSpPr/>
                <p:nvPr/>
              </p:nvSpPr>
              <p:spPr>
                <a:xfrm>
                  <a:off x="5451480" y="6447960"/>
                  <a:ext cx="7995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Starvation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Straight Connector 20"/>
                <p:cNvSpPr/>
                <p:nvPr/>
              </p:nvSpPr>
              <p:spPr>
                <a:xfrm>
                  <a:off x="5520960" y="2344320"/>
                  <a:ext cx="0" cy="2087640"/>
                </a:xfrm>
                <a:prstGeom prst="line">
                  <a:avLst/>
                </a:prstGeom>
                <a:ln w="76320">
                  <a:solidFill>
                    <a:srgbClr val="c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Straight Connector 21"/>
                <p:cNvSpPr/>
                <p:nvPr/>
              </p:nvSpPr>
              <p:spPr>
                <a:xfrm>
                  <a:off x="5517720" y="5152680"/>
                  <a:ext cx="0" cy="1152360"/>
                </a:xfrm>
                <a:prstGeom prst="line">
                  <a:avLst/>
                </a:prstGeom>
                <a:ln w="7632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TextBox 22"/>
                <p:cNvSpPr/>
                <p:nvPr/>
              </p:nvSpPr>
              <p:spPr>
                <a:xfrm>
                  <a:off x="5451120" y="5655960"/>
                  <a:ext cx="976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VT pathway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1" name="Group 33"/>
                <p:cNvGrpSpPr/>
                <p:nvPr/>
              </p:nvGrpSpPr>
              <p:grpSpPr>
                <a:xfrm>
                  <a:off x="5661000" y="4144320"/>
                  <a:ext cx="0" cy="1368360"/>
                  <a:chOff x="5661000" y="4144320"/>
                  <a:chExt cx="0" cy="1368360"/>
                </a:xfrm>
              </p:grpSpPr>
              <p:sp>
                <p:nvSpPr>
                  <p:cNvPr id="112" name="Straight Connector 25"/>
                  <p:cNvSpPr/>
                  <p:nvPr/>
                </p:nvSpPr>
                <p:spPr>
                  <a:xfrm>
                    <a:off x="5661000" y="4144320"/>
                    <a:ext cx="0" cy="792000"/>
                  </a:xfrm>
                  <a:prstGeom prst="line">
                    <a:avLst/>
                  </a:prstGeom>
                  <a:ln w="76320">
                    <a:solidFill>
                      <a:srgbClr val="00b05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Straight Connector 26"/>
                  <p:cNvSpPr/>
                  <p:nvPr/>
                </p:nvSpPr>
                <p:spPr>
                  <a:xfrm>
                    <a:off x="5661000" y="4936320"/>
                    <a:ext cx="0" cy="576360"/>
                  </a:xfrm>
                  <a:prstGeom prst="line">
                    <a:avLst/>
                  </a:prstGeom>
                  <a:ln w="76320">
                    <a:solidFill>
                      <a:srgbClr val="c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14" name="TextBox 24"/>
                <p:cNvSpPr/>
                <p:nvPr/>
              </p:nvSpPr>
              <p:spPr>
                <a:xfrm>
                  <a:off x="5632920" y="4935960"/>
                  <a:ext cx="1171440" cy="550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000" spc="-1" strike="noStrike">
                      <a:solidFill>
                        <a:srgbClr val="000000"/>
                      </a:solidFill>
                      <a:latin typeface="Arial"/>
                    </a:rPr>
                    <a:t>Core machinery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000" spc="-1" strike="noStrike">
                      <a:solidFill>
                        <a:srgbClr val="000000"/>
                      </a:solidFill>
                      <a:latin typeface="Arial"/>
                    </a:rPr>
                    <a:t>for membrane 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CA" sz="1000" spc="-1" strike="noStrike">
                      <a:solidFill>
                        <a:srgbClr val="000000"/>
                      </a:solidFill>
                      <a:latin typeface="Arial"/>
                    </a:rPr>
                    <a:t>formation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5" name="TextBox 27"/>
              <p:cNvSpPr/>
              <p:nvPr/>
            </p:nvSpPr>
            <p:spPr>
              <a:xfrm>
                <a:off x="5488200" y="3085200"/>
                <a:ext cx="1171440" cy="550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000" spc="-1" strike="noStrike">
                    <a:solidFill>
                      <a:srgbClr val="000000"/>
                    </a:solidFill>
                    <a:latin typeface="Arial"/>
                  </a:rPr>
                  <a:t>Core machinery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000" spc="-1" strike="noStrike">
                    <a:solidFill>
                      <a:srgbClr val="000000"/>
                    </a:solidFill>
                    <a:latin typeface="Arial"/>
                  </a:rPr>
                  <a:t>for membrane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CA" sz="1000" spc="-1" strike="noStrike">
                    <a:solidFill>
                      <a:srgbClr val="000000"/>
                    </a:solidFill>
                    <a:latin typeface="Arial"/>
                  </a:rPr>
                  <a:t>formatio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6" name="TextBox 18"/>
            <p:cNvSpPr/>
            <p:nvPr/>
          </p:nvSpPr>
          <p:spPr>
            <a:xfrm>
              <a:off x="568800" y="14349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19"/>
            <p:cNvSpPr/>
            <p:nvPr/>
          </p:nvSpPr>
          <p:spPr>
            <a:xfrm>
              <a:off x="4903920" y="14241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22"/>
            <p:cNvSpPr/>
            <p:nvPr/>
          </p:nvSpPr>
          <p:spPr>
            <a:xfrm>
              <a:off x="2564640" y="1424160"/>
              <a:ext cx="72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Z-sco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Picture 2" descr=""/>
          <p:cNvPicPr/>
          <p:nvPr/>
        </p:nvPicPr>
        <p:blipFill>
          <a:blip r:embed="rId1"/>
          <a:stretch/>
        </p:blipFill>
        <p:spPr>
          <a:xfrm>
            <a:off x="476280" y="1281240"/>
            <a:ext cx="6099120" cy="2943000"/>
          </a:xfrm>
          <a:prstGeom prst="rect">
            <a:avLst/>
          </a:prstGeom>
          <a:ln w="0">
            <a:noFill/>
          </a:ln>
        </p:spPr>
      </p:pic>
      <p:sp>
        <p:nvSpPr>
          <p:cNvPr id="120" name="TextBox 2"/>
          <p:cNvSpPr/>
          <p:nvPr/>
        </p:nvSpPr>
        <p:spPr>
          <a:xfrm>
            <a:off x="549360" y="560520"/>
            <a:ext cx="5688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Table S3 – </a:t>
            </a: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 Network density and clustering coefficient are not correlated with the fraction of membrane interactions reported by each techniqu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1T16:54:09Z</dcterms:created>
  <dc:creator>Owner</dc:creator>
  <dc:description/>
  <dc:language>en-US</dc:language>
  <cp:lastModifiedBy>gilb01</cp:lastModifiedBy>
  <dcterms:modified xsi:type="dcterms:W3CDTF">2011-10-14T14:26:46Z</dcterms:modified>
  <cp:revision>560</cp:revision>
  <dc:subject/>
  <dc:title>Slide 1</dc:title>
</cp:coreProperties>
</file>